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12193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C057D-7C40-48D5-A016-4A9D9E186E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150CA-3107-4D0A-9951-B4A92C588A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8EFDC-ACDE-4B5E-A242-699F41CB71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3244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7285320"/>
            <a:ext cx="33858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FE19F-EBD3-4E4D-9FC5-026CB4C01F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38"/>
              </a:spcBef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4599A-78B1-4D94-96C1-4DB50975E9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B3840C-5043-4D1C-8DB9-B86FE5CAA9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726621-D57F-4F17-9968-5638DA09E4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5B9740-AD86-4BE1-B4C8-DCD76249A2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649440"/>
            <a:ext cx="10515600" cy="10921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38"/>
              </a:spcBef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91603-A36C-405D-95A1-7FE5D901BD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A2B1A-5C6A-4F1F-9FF6-D7344CF6E1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7285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B6144-A63B-4E1E-8AFF-AB5B344D63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3244320"/>
            <a:ext cx="513144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7285320"/>
            <a:ext cx="10515600" cy="369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38"/>
              </a:spcBef>
              <a:buNone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C029FA-246D-4296-99AA-325E30AF65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649440"/>
            <a:ext cx="10515600" cy="2355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3244320"/>
            <a:ext cx="10515600" cy="773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31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1" marL="9129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2" marL="152244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3" marL="2131920" indent="-30312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4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5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  <a:p>
            <a:pPr lvl="6" marL="2741760" indent="-303480">
              <a:lnSpc>
                <a:spcPct val="90000"/>
              </a:lnSpc>
              <a:spcBef>
                <a:spcPts val="1338"/>
              </a:spcBef>
              <a:buClr>
                <a:srgbClr val="000000"/>
              </a:buClr>
              <a:buFont typeface="Arial"/>
              <a:buChar char="•"/>
              <a:tabLst>
                <a:tab algn="l" pos="1217520"/>
                <a:tab algn="l" pos="2435400"/>
                <a:tab algn="l" pos="3652920"/>
                <a:tab algn="l" pos="4870440"/>
                <a:tab algn="l" pos="6087960"/>
                <a:tab algn="l" pos="7305840"/>
                <a:tab algn="l" pos="8523360"/>
                <a:tab algn="l" pos="9740880"/>
                <a:tab algn="l" pos="10958400"/>
              </a:tabLst>
            </a:pPr>
            <a:r>
              <a:rPr b="0" lang="en-US" sz="37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date/time&gt;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11299680"/>
            <a:ext cx="41148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11299680"/>
            <a:ext cx="2743200" cy="649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600" spc="-1" strike="noStrike">
                <a:solidFill>
                  <a:srgbClr val="898989"/>
                </a:solidFill>
                <a:latin typeface="Calibri"/>
                <a:ea typeface="Yu Gothic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E294A1C-FDF1-4D35-979A-10F22DE99CC5}" type="slidenum">
              <a:rPr b="0" lang="ja-JP" sz="1600" spc="-1" strike="noStrike">
                <a:solidFill>
                  <a:srgbClr val="898989"/>
                </a:solidFill>
                <a:latin typeface="Calibri"/>
                <a:ea typeface="Yu Gothic"/>
              </a:rPr>
              <a:t>&lt;number&gt;</a:t>
            </a:fld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4"/>
          <p:cNvSpPr/>
          <p:nvPr/>
        </p:nvSpPr>
        <p:spPr>
          <a:xfrm>
            <a:off x="1278000" y="1825560"/>
            <a:ext cx="9920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Supplementary Material 2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Yu Gothic"/>
              </a:rPr>
              <a:t>. </a:t>
            </a: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Yu Gothic"/>
              </a:rPr>
              <a:t>Derivation of age at smoking initiation using smoking duration among ever-smoker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1277640" y="3112920"/>
            <a:ext cx="9636480" cy="5965920"/>
            <a:chOff x="1277640" y="3112920"/>
            <a:chExt cx="9636480" cy="5965920"/>
          </a:xfrm>
        </p:grpSpPr>
        <p:grpSp>
          <p:nvGrpSpPr>
            <p:cNvPr id="43" name="Group 15"/>
            <p:cNvGrpSpPr/>
            <p:nvPr/>
          </p:nvGrpSpPr>
          <p:grpSpPr>
            <a:xfrm>
              <a:off x="1277640" y="3112920"/>
              <a:ext cx="9636480" cy="5965920"/>
              <a:chOff x="1277640" y="3112920"/>
              <a:chExt cx="9636480" cy="5965920"/>
            </a:xfrm>
          </p:grpSpPr>
          <p:grpSp>
            <p:nvGrpSpPr>
              <p:cNvPr id="44" name="Group 20"/>
              <p:cNvGrpSpPr/>
              <p:nvPr/>
            </p:nvGrpSpPr>
            <p:grpSpPr>
              <a:xfrm>
                <a:off x="1344600" y="3112920"/>
                <a:ext cx="9569520" cy="2608920"/>
                <a:chOff x="1344600" y="3112920"/>
                <a:chExt cx="9569520" cy="2608920"/>
              </a:xfrm>
            </p:grpSpPr>
            <p:cxnSp>
              <p:nvCxnSpPr>
                <p:cNvPr id="45" name="Straight Arrow Connector 40"/>
                <p:cNvCxnSpPr/>
                <p:nvPr/>
              </p:nvCxnSpPr>
              <p:spPr>
                <a:xfrm>
                  <a:off x="1344600" y="4380840"/>
                  <a:ext cx="9569880" cy="1080"/>
                </a:xfrm>
                <a:prstGeom prst="straightConnector1">
                  <a:avLst/>
                </a:prstGeom>
                <a:ln w="64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46" name="Straight Connector 41"/>
                <p:cNvSpPr/>
                <p:nvPr/>
              </p:nvSpPr>
              <p:spPr>
                <a:xfrm>
                  <a:off x="2349720" y="426708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7" name="Straight Connector 42"/>
                <p:cNvSpPr/>
                <p:nvPr/>
              </p:nvSpPr>
              <p:spPr>
                <a:xfrm>
                  <a:off x="6564600" y="426708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8" name="Straight Connector 43"/>
                <p:cNvSpPr/>
                <p:nvPr/>
              </p:nvSpPr>
              <p:spPr>
                <a:xfrm>
                  <a:off x="8547480" y="425736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Straight Connector 44"/>
                <p:cNvSpPr/>
                <p:nvPr/>
              </p:nvSpPr>
              <p:spPr>
                <a:xfrm>
                  <a:off x="10044360" y="426708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50" name="Straight Arrow Connector 45"/>
                <p:cNvCxnSpPr/>
                <p:nvPr/>
              </p:nvCxnSpPr>
              <p:spPr>
                <a:xfrm>
                  <a:off x="2295720" y="4792320"/>
                  <a:ext cx="431064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sp>
              <p:nvSpPr>
                <p:cNvPr id="51" name="Text Box 4"/>
                <p:cNvSpPr/>
                <p:nvPr/>
              </p:nvSpPr>
              <p:spPr>
                <a:xfrm>
                  <a:off x="1475280" y="3654720"/>
                  <a:ext cx="191556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Smoking initi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Text Box 4"/>
                <p:cNvSpPr/>
                <p:nvPr/>
              </p:nvSpPr>
              <p:spPr>
                <a:xfrm>
                  <a:off x="5876280" y="3795480"/>
                  <a:ext cx="14418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Examin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Text Box 4"/>
                <p:cNvSpPr/>
                <p:nvPr/>
              </p:nvSpPr>
              <p:spPr>
                <a:xfrm>
                  <a:off x="7819200" y="3699720"/>
                  <a:ext cx="14418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Lung cancer diagnosis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Text Box 4"/>
                <p:cNvSpPr/>
                <p:nvPr/>
              </p:nvSpPr>
              <p:spPr>
                <a:xfrm>
                  <a:off x="9616680" y="3795480"/>
                  <a:ext cx="8550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Death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55" name="Straight Arrow Connector 50"/>
                <p:cNvCxnSpPr/>
                <p:nvPr/>
              </p:nvCxnSpPr>
              <p:spPr>
                <a:xfrm>
                  <a:off x="2295360" y="5204880"/>
                  <a:ext cx="627444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cxnSp>
              <p:nvCxnSpPr>
                <p:cNvPr id="56" name="Straight Arrow Connector 51"/>
                <p:cNvCxnSpPr/>
                <p:nvPr/>
              </p:nvCxnSpPr>
              <p:spPr>
                <a:xfrm>
                  <a:off x="2295360" y="5655960"/>
                  <a:ext cx="779508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sp>
              <p:nvSpPr>
                <p:cNvPr id="57" name="Text Box 4"/>
                <p:cNvSpPr/>
                <p:nvPr/>
              </p:nvSpPr>
              <p:spPr>
                <a:xfrm>
                  <a:off x="3615480" y="4417920"/>
                  <a:ext cx="191592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Text Box 4"/>
                <p:cNvSpPr/>
                <p:nvPr/>
              </p:nvSpPr>
              <p:spPr>
                <a:xfrm>
                  <a:off x="5085360" y="5261400"/>
                  <a:ext cx="251208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Lifetime 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 Box 4"/>
                <p:cNvSpPr/>
                <p:nvPr/>
              </p:nvSpPr>
              <p:spPr>
                <a:xfrm>
                  <a:off x="4322520" y="4819680"/>
                  <a:ext cx="241884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Individual latency period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Text Box 4"/>
                <p:cNvSpPr/>
                <p:nvPr/>
              </p:nvSpPr>
              <p:spPr>
                <a:xfrm>
                  <a:off x="1651320" y="3112920"/>
                  <a:ext cx="1731960" cy="477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5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Current smokers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Text Box 4"/>
                <p:cNvSpPr/>
                <p:nvPr/>
              </p:nvSpPr>
              <p:spPr>
                <a:xfrm>
                  <a:off x="2104560" y="3855600"/>
                  <a:ext cx="49284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5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ff0000"/>
                      </a:solidFill>
                      <a:latin typeface="Arial"/>
                      <a:ea typeface="바탕"/>
                    </a:rPr>
                    <a:t>?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Text Box 4"/>
                <p:cNvSpPr/>
                <p:nvPr/>
              </p:nvSpPr>
              <p:spPr>
                <a:xfrm>
                  <a:off x="3457080" y="3132720"/>
                  <a:ext cx="614052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70c0"/>
                      </a:solidFill>
                      <a:latin typeface="Arial"/>
                      <a:ea typeface="바탕"/>
                    </a:rPr>
                    <a:t>Age at smoking initiation = Age at examination – 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3" name="Group 21"/>
              <p:cNvGrpSpPr/>
              <p:nvPr/>
            </p:nvGrpSpPr>
            <p:grpSpPr>
              <a:xfrm>
                <a:off x="1277640" y="6490080"/>
                <a:ext cx="9593280" cy="2588760"/>
                <a:chOff x="1277640" y="6490080"/>
                <a:chExt cx="9593280" cy="2588760"/>
              </a:xfrm>
            </p:grpSpPr>
            <p:cxnSp>
              <p:nvCxnSpPr>
                <p:cNvPr id="64" name="Straight Arrow Connector 22"/>
                <p:cNvCxnSpPr/>
                <p:nvPr/>
              </p:nvCxnSpPr>
              <p:spPr>
                <a:xfrm>
                  <a:off x="1277640" y="7738920"/>
                  <a:ext cx="9570600" cy="1080"/>
                </a:xfrm>
                <a:prstGeom prst="straightConnector1">
                  <a:avLst/>
                </a:prstGeom>
                <a:ln w="6480">
                  <a:solidFill>
                    <a:srgbClr val="000000"/>
                  </a:solidFill>
                  <a:miter/>
                  <a:tailEnd len="med" type="triangle" w="med"/>
                </a:ln>
              </p:spPr>
            </p:cxnSp>
            <p:sp>
              <p:nvSpPr>
                <p:cNvPr id="65" name="Straight Connector 23"/>
                <p:cNvSpPr/>
                <p:nvPr/>
              </p:nvSpPr>
              <p:spPr>
                <a:xfrm>
                  <a:off x="2282760" y="762480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6" name="Straight Connector 24"/>
                <p:cNvSpPr/>
                <p:nvPr/>
              </p:nvSpPr>
              <p:spPr>
                <a:xfrm>
                  <a:off x="6656760" y="762480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7" name="Straight Connector 25"/>
                <p:cNvSpPr/>
                <p:nvPr/>
              </p:nvSpPr>
              <p:spPr>
                <a:xfrm>
                  <a:off x="8676000" y="7613640"/>
                  <a:ext cx="0" cy="2412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8" name="Straight Connector 26"/>
                <p:cNvSpPr/>
                <p:nvPr/>
              </p:nvSpPr>
              <p:spPr>
                <a:xfrm>
                  <a:off x="9977760" y="7624800"/>
                  <a:ext cx="0" cy="239400"/>
                </a:xfrm>
                <a:prstGeom prst="line">
                  <a:avLst/>
                </a:prstGeom>
                <a:ln w="19080">
                  <a:solidFill>
                    <a:srgbClr val="181717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69" name="Straight Arrow Connector 27"/>
                <p:cNvCxnSpPr/>
                <p:nvPr/>
              </p:nvCxnSpPr>
              <p:spPr>
                <a:xfrm>
                  <a:off x="2228760" y="8150040"/>
                  <a:ext cx="221832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sp>
              <p:nvSpPr>
                <p:cNvPr id="70" name="Text Box 4"/>
                <p:cNvSpPr/>
                <p:nvPr/>
              </p:nvSpPr>
              <p:spPr>
                <a:xfrm>
                  <a:off x="1407960" y="7012080"/>
                  <a:ext cx="191592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Smoking initi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" name="Text Box 4"/>
                <p:cNvSpPr/>
                <p:nvPr/>
              </p:nvSpPr>
              <p:spPr>
                <a:xfrm>
                  <a:off x="5936400" y="7212960"/>
                  <a:ext cx="1441800" cy="467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Examin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2" name="Text Box 4"/>
                <p:cNvSpPr/>
                <p:nvPr/>
              </p:nvSpPr>
              <p:spPr>
                <a:xfrm>
                  <a:off x="7947720" y="7057080"/>
                  <a:ext cx="14418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Lung cancer diagnosis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Text Box 4"/>
                <p:cNvSpPr/>
                <p:nvPr/>
              </p:nvSpPr>
              <p:spPr>
                <a:xfrm>
                  <a:off x="9549720" y="7152840"/>
                  <a:ext cx="8550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Death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cxnSp>
              <p:nvCxnSpPr>
                <p:cNvPr id="74" name="Straight Arrow Connector 32"/>
                <p:cNvCxnSpPr/>
                <p:nvPr/>
              </p:nvCxnSpPr>
              <p:spPr>
                <a:xfrm>
                  <a:off x="2228400" y="8561160"/>
                  <a:ext cx="646524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cxnSp>
              <p:nvCxnSpPr>
                <p:cNvPr id="75" name="Straight Arrow Connector 33"/>
                <p:cNvCxnSpPr/>
                <p:nvPr/>
              </p:nvCxnSpPr>
              <p:spPr>
                <a:xfrm>
                  <a:off x="2228400" y="9013680"/>
                  <a:ext cx="7795800" cy="1080"/>
                </a:xfrm>
                <a:prstGeom prst="straightConnector1">
                  <a:avLst/>
                </a:prstGeom>
                <a:ln w="6480">
                  <a:solidFill>
                    <a:srgbClr val="4472c4"/>
                  </a:solidFill>
                  <a:miter/>
                  <a:headEnd len="med" type="triangle" w="med"/>
                  <a:tailEnd len="med" type="triangle" w="med"/>
                </a:ln>
              </p:spPr>
            </p:cxnSp>
            <p:sp>
              <p:nvSpPr>
                <p:cNvPr id="76" name="Text Box 4"/>
                <p:cNvSpPr/>
                <p:nvPr/>
              </p:nvSpPr>
              <p:spPr>
                <a:xfrm>
                  <a:off x="2459520" y="7775280"/>
                  <a:ext cx="191592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7" name="Text Box 4"/>
                <p:cNvSpPr/>
                <p:nvPr/>
              </p:nvSpPr>
              <p:spPr>
                <a:xfrm>
                  <a:off x="5195160" y="8618400"/>
                  <a:ext cx="251208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Lifetime 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8" name="Text Box 4"/>
                <p:cNvSpPr/>
                <p:nvPr/>
              </p:nvSpPr>
              <p:spPr>
                <a:xfrm>
                  <a:off x="4339080" y="8176680"/>
                  <a:ext cx="241920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Individual latency period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9" name="Text Box 4"/>
                <p:cNvSpPr/>
                <p:nvPr/>
              </p:nvSpPr>
              <p:spPr>
                <a:xfrm>
                  <a:off x="1584360" y="6490080"/>
                  <a:ext cx="1731960" cy="477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5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  <a:ea typeface="바탕"/>
                    </a:rPr>
                    <a:t>Former smokers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0" name="Text Box 4"/>
                <p:cNvSpPr/>
                <p:nvPr/>
              </p:nvSpPr>
              <p:spPr>
                <a:xfrm>
                  <a:off x="2037240" y="7212960"/>
                  <a:ext cx="49284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5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ff0000"/>
                      </a:solidFill>
                      <a:latin typeface="Arial"/>
                      <a:ea typeface="바탕"/>
                    </a:rPr>
                    <a:t>?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Text Box 4"/>
                <p:cNvSpPr/>
                <p:nvPr/>
              </p:nvSpPr>
              <p:spPr>
                <a:xfrm>
                  <a:off x="3380400" y="6510240"/>
                  <a:ext cx="7490520" cy="460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400" spc="-1" strike="noStrike">
                      <a:solidFill>
                        <a:srgbClr val="0070c0"/>
                      </a:solidFill>
                      <a:latin typeface="Arial"/>
                      <a:ea typeface="바탕"/>
                    </a:rPr>
                    <a:t>Age at smoking initiation = Age at examination + Quitting duration – Smoking duration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sp>
          <p:nvSpPr>
            <p:cNvPr id="82" name="Straight Connector 16"/>
            <p:cNvSpPr/>
            <p:nvPr/>
          </p:nvSpPr>
          <p:spPr>
            <a:xfrm>
              <a:off x="4419720" y="7624800"/>
              <a:ext cx="0" cy="237960"/>
            </a:xfrm>
            <a:prstGeom prst="line">
              <a:avLst/>
            </a:prstGeom>
            <a:ln w="19080">
              <a:solidFill>
                <a:srgbClr val="181717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Text Box 4"/>
            <p:cNvSpPr/>
            <p:nvPr/>
          </p:nvSpPr>
          <p:spPr>
            <a:xfrm>
              <a:off x="3555720" y="7208280"/>
              <a:ext cx="1727640" cy="46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바탕"/>
                </a:rPr>
                <a:t>Smoking cessa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84" name="Straight Arrow Connector 18"/>
            <p:cNvCxnSpPr/>
            <p:nvPr/>
          </p:nvCxnSpPr>
          <p:spPr>
            <a:xfrm>
              <a:off x="4452840" y="8154720"/>
              <a:ext cx="2218320" cy="1080"/>
            </a:xfrm>
            <a:prstGeom prst="straightConnector1">
              <a:avLst/>
            </a:prstGeom>
            <a:ln w="6480">
              <a:solidFill>
                <a:srgbClr val="4472c4"/>
              </a:solidFill>
              <a:miter/>
              <a:headEnd len="med" type="triangle" w="med"/>
              <a:tailEnd len="med" type="triangle" w="med"/>
            </a:ln>
          </p:spPr>
        </p:cxnSp>
        <p:sp>
          <p:nvSpPr>
            <p:cNvPr id="85" name="Text Box 4"/>
            <p:cNvSpPr/>
            <p:nvPr/>
          </p:nvSpPr>
          <p:spPr>
            <a:xfrm>
              <a:off x="4687560" y="7781040"/>
              <a:ext cx="1914840" cy="45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바탕"/>
                </a:rPr>
                <a:t>Quitting durat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11-08T14:40:59Z</dcterms:created>
  <dc:creator>JE editorial office</dc:creator>
  <dc:description/>
  <dc:language>en-US</dc:language>
  <cp:lastModifiedBy>이제인</cp:lastModifiedBy>
  <dcterms:modified xsi:type="dcterms:W3CDTF">2026-05-28T04:14:25Z</dcterms:modified>
  <cp:revision>4</cp:revision>
  <dc:subject/>
  <dc:title>PowerPoint プレゼンテーション</dc:title>
</cp:coreProperties>
</file>